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4" r:id="rId2"/>
    <p:sldId id="265" r:id="rId3"/>
    <p:sldId id="266" r:id="rId4"/>
    <p:sldId id="269" r:id="rId5"/>
    <p:sldId id="270" r:id="rId6"/>
    <p:sldId id="267" r:id="rId7"/>
    <p:sldId id="271" r:id="rId8"/>
    <p:sldId id="268" r:id="rId9"/>
    <p:sldId id="263" r:id="rId10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7" autoAdjust="0"/>
    <p:restoredTop sz="94660"/>
  </p:normalViewPr>
  <p:slideViewPr>
    <p:cSldViewPr snapToGrid="0">
      <p:cViewPr varScale="1">
        <p:scale>
          <a:sx n="77" d="100"/>
          <a:sy n="77" d="100"/>
        </p:scale>
        <p:origin x="854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E73CD89-B887-0FC3-E24E-DDD1D8F4D6D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IE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B7808D0-D199-BB3B-3EA9-E641B8EB218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I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C9AE1F7-2CEA-8553-B02F-B290887EBC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76447C-EA51-4E1C-B30D-4F177EC631B8}" type="datetimeFigureOut">
              <a:rPr lang="en-IE" smtClean="0"/>
              <a:t>06/08/2024</a:t>
            </a:fld>
            <a:endParaRPr lang="en-I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D953094-EA98-6B2D-4A27-93790CD506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21DDCB0-9BAB-1A8D-CAA2-82A904B5BC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558854-1307-4A8F-8B1B-D419FACAFFD1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5989062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395A6A8-3AF2-CD5E-9999-21C4AAD3909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3A519F9-6576-1709-282A-5E114385776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B3A6D36-B45A-C7ED-CF3B-EE0873AD9B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76447C-EA51-4E1C-B30D-4F177EC631B8}" type="datetimeFigureOut">
              <a:rPr lang="en-IE" smtClean="0"/>
              <a:t>06/08/2024</a:t>
            </a:fld>
            <a:endParaRPr lang="en-I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B49A15D-FC35-6ED1-9752-490D2ECBF1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5371C55-6D47-58A6-BC1D-09A277F378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558854-1307-4A8F-8B1B-D419FACAFFD1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5711970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75BB031-946E-A316-E0A2-6F419704F27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525C15A-843A-3CD0-4DB8-0CD58DF7D31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7A03DF2-0D4C-DAC1-656F-2DB29C6EFB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76447C-EA51-4E1C-B30D-4F177EC631B8}" type="datetimeFigureOut">
              <a:rPr lang="en-IE" smtClean="0"/>
              <a:t>06/08/2024</a:t>
            </a:fld>
            <a:endParaRPr lang="en-I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D16601E-9301-811B-BB31-C1695D2BE4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AC08B18-97F1-CE73-3C51-1797EF29B4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558854-1307-4A8F-8B1B-D419FACAFFD1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27776334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787B567-96AA-14C5-F792-B86F33F5AD8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929193E-4F0E-B361-2204-9E05B6FB844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DE829C6-EC31-993B-B8FA-EAEA496737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76447C-EA51-4E1C-B30D-4F177EC631B8}" type="datetimeFigureOut">
              <a:rPr lang="en-IE" smtClean="0"/>
              <a:t>06/08/2024</a:t>
            </a:fld>
            <a:endParaRPr lang="en-I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E118279-899B-1FB2-A213-0D20B924FE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F775211-1772-B0A5-8E1C-81580BB382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558854-1307-4A8F-8B1B-D419FACAFFD1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34440250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3716F70-0DC8-BBFC-233A-9B9B1D8E45C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I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11246F1-4B90-BFC9-B940-40497B55D44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D603A96-0F32-96B2-EA2E-DB8A35FDBF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76447C-EA51-4E1C-B30D-4F177EC631B8}" type="datetimeFigureOut">
              <a:rPr lang="en-IE" smtClean="0"/>
              <a:t>06/08/2024</a:t>
            </a:fld>
            <a:endParaRPr lang="en-I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1E30E08-0CA4-CB1B-DD77-8171E94AFD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CF92694-87E9-A301-393A-E0AD7FAD42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558854-1307-4A8F-8B1B-D419FACAFFD1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4737412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7A347CB-7A90-81E4-B6ED-06FDF863BCE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2FFB10E-5A13-6DF9-A566-1DA6C8900BF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E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473FBD8-E967-B1E4-8D4B-22F029C0681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E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F19C5B7-A648-7451-591C-5403193242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76447C-EA51-4E1C-B30D-4F177EC631B8}" type="datetimeFigureOut">
              <a:rPr lang="en-IE" smtClean="0"/>
              <a:t>06/08/2024</a:t>
            </a:fld>
            <a:endParaRPr lang="en-I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818EBE6-73B5-78D6-DC04-5B4C972BD9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DF9BFDC-07B9-BB25-ED97-4196EE24F9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558854-1307-4A8F-8B1B-D419FACAFFD1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7879629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31F0C03-6BEC-5EB7-CE58-0DBBD709C46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5139776-79BC-7E7D-957D-D454CF91985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73C989E-7083-BED5-2284-67BFB21BE87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E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42DA523-707E-8A2B-BC3A-973F9AB10FC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04EA73C-3C7C-8ADB-4B59-33535F4A533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E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38AD139-5212-F2A5-2C29-CBA1B54534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76447C-EA51-4E1C-B30D-4F177EC631B8}" type="datetimeFigureOut">
              <a:rPr lang="en-IE" smtClean="0"/>
              <a:t>06/08/2024</a:t>
            </a:fld>
            <a:endParaRPr lang="en-IE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E6DACA1-2605-D68C-C630-1CFFDCAB3F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528B3C0-001B-6145-BFC5-A56AD99B7F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558854-1307-4A8F-8B1B-D419FACAFFD1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723452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DF86589-9B1C-3557-F62F-1C49BE52E32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E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C53AF14-73D9-918F-718B-E99B36229C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76447C-EA51-4E1C-B30D-4F177EC631B8}" type="datetimeFigureOut">
              <a:rPr lang="en-IE" smtClean="0"/>
              <a:t>06/08/2024</a:t>
            </a:fld>
            <a:endParaRPr lang="en-IE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2D40A56-49F8-8D02-6E4A-5839EC9890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3F7FEE8-79E9-C869-E146-2D71E5C0A8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558854-1307-4A8F-8B1B-D419FACAFFD1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068791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81586A3-3A72-811D-2780-0BDEC642BD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76447C-EA51-4E1C-B30D-4F177EC631B8}" type="datetimeFigureOut">
              <a:rPr lang="en-IE" smtClean="0"/>
              <a:t>06/08/2024</a:t>
            </a:fld>
            <a:endParaRPr lang="en-I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41C705D-C180-3C91-E4A5-486E13AC41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F65FD4D-D6C4-89FB-4498-F86913317D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558854-1307-4A8F-8B1B-D419FACAFFD1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6272644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B1FA3D2-EB3D-A745-01EF-09B54BBA97C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042E871-D37A-80AC-1B1C-107D75A162D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1960E10-603D-0E03-ADFB-018A673A552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C9A4A68-05D1-9871-84DA-E2345EA12D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76447C-EA51-4E1C-B30D-4F177EC631B8}" type="datetimeFigureOut">
              <a:rPr lang="en-IE" smtClean="0"/>
              <a:t>06/08/2024</a:t>
            </a:fld>
            <a:endParaRPr lang="en-I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92AAD2C-1E11-F8E3-1E19-8981E829FD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C767EBD-288F-4E52-156C-A7FA2F3CF6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558854-1307-4A8F-8B1B-D419FACAFFD1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30839811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6A4872F-1408-5933-DC52-3BCE3E1512B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E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3129F6F-0F67-22E7-47F4-297AC21AC80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117EC9C-3169-FB05-99AD-1853B107901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2FD20C2-3B79-2526-8DA5-923D384D02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76447C-EA51-4E1C-B30D-4F177EC631B8}" type="datetimeFigureOut">
              <a:rPr lang="en-IE" smtClean="0"/>
              <a:t>06/08/2024</a:t>
            </a:fld>
            <a:endParaRPr lang="en-I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9E5CCAC-33D2-3A9D-D695-9F574E1836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A2BC96C-6D5B-1CF8-F162-98886426F8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558854-1307-4A8F-8B1B-D419FACAFFD1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33137703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A0DA0B7-9508-9DF1-177B-E1C22A0E4CB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9156821-5B51-21B8-D85B-2890FC6E097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299F3C8-892E-F82C-4D45-2EE5B0DFE85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C76447C-EA51-4E1C-B30D-4F177EC631B8}" type="datetimeFigureOut">
              <a:rPr lang="en-IE" smtClean="0"/>
              <a:t>06/08/2024</a:t>
            </a:fld>
            <a:endParaRPr lang="en-I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9B9CE09-77A8-5E55-5B59-D79B4B3E0E2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I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41C3AC3-4B98-349A-401B-330189521E6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B558854-1307-4A8F-8B1B-D419FACAFFD1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20245350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"/><Relationship Id="rId2" Type="http://schemas.openxmlformats.org/officeDocument/2006/relationships/image" Target="../media/image4.ti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7.tif"/><Relationship Id="rId4" Type="http://schemas.openxmlformats.org/officeDocument/2006/relationships/image" Target="../media/image6.ti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tif"/><Relationship Id="rId2" Type="http://schemas.openxmlformats.org/officeDocument/2006/relationships/image" Target="../media/image8.ti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1.tif"/><Relationship Id="rId4" Type="http://schemas.openxmlformats.org/officeDocument/2006/relationships/image" Target="../media/image10.tif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Chart, scatter chart&#10;&#10;Description automatically generated">
            <a:extLst>
              <a:ext uri="{FF2B5EF4-FFF2-40B4-BE49-F238E27FC236}">
                <a16:creationId xmlns:a16="http://schemas.microsoft.com/office/drawing/2014/main" id="{77464BE7-42D9-8CA2-E441-F48EF204064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12952" y="514350"/>
            <a:ext cx="10462472" cy="575309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1309713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Chart&#10;&#10;Description automatically generated">
            <a:extLst>
              <a:ext uri="{FF2B5EF4-FFF2-40B4-BE49-F238E27FC236}">
                <a16:creationId xmlns:a16="http://schemas.microsoft.com/office/drawing/2014/main" id="{0279E08F-7F55-FFFC-778B-11ABBDA1DAD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69953" y="323851"/>
            <a:ext cx="10725614" cy="625316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8547214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Chart&#10;&#10;Description automatically generated">
            <a:extLst>
              <a:ext uri="{FF2B5EF4-FFF2-40B4-BE49-F238E27FC236}">
                <a16:creationId xmlns:a16="http://schemas.microsoft.com/office/drawing/2014/main" id="{C3889990-164A-210C-FBE4-DBEF63415F7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89061" y="338454"/>
            <a:ext cx="9542973" cy="613854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0497330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grey background with green dots&#10;&#10;Description automatically generated">
            <a:extLst>
              <a:ext uri="{FF2B5EF4-FFF2-40B4-BE49-F238E27FC236}">
                <a16:creationId xmlns:a16="http://schemas.microsoft.com/office/drawing/2014/main" id="{AD9E302D-3DDB-7D47-3286-E06DF0ECE15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8110" y="3403710"/>
            <a:ext cx="4450556" cy="328734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Picture 4" descr="A grey background with green dots&#10;&#10;Description automatically generated">
            <a:extLst>
              <a:ext uri="{FF2B5EF4-FFF2-40B4-BE49-F238E27FC236}">
                <a16:creationId xmlns:a16="http://schemas.microsoft.com/office/drawing/2014/main" id="{9568C18B-9CA0-748E-1D5E-22841DCA311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93427" y="112630"/>
            <a:ext cx="4436271" cy="327679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Picture 6" descr="A grey background with green specks&#10;&#10;Description automatically generated">
            <a:extLst>
              <a:ext uri="{FF2B5EF4-FFF2-40B4-BE49-F238E27FC236}">
                <a16:creationId xmlns:a16="http://schemas.microsoft.com/office/drawing/2014/main" id="{0789FFC6-C992-71E9-0F0A-CE20C4B1C2F8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2870" y="112631"/>
            <a:ext cx="4436271" cy="327679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" name="Picture 8" descr="A grey and green background&#10;&#10;Description automatically generated">
            <a:extLst>
              <a:ext uri="{FF2B5EF4-FFF2-40B4-BE49-F238E27FC236}">
                <a16:creationId xmlns:a16="http://schemas.microsoft.com/office/drawing/2014/main" id="{D33201B8-A8B2-2D35-E12C-4396207ED1EE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88666" y="3408473"/>
            <a:ext cx="4450556" cy="328734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EB5C98F0-B7A2-866C-5B14-D5F4D08B1498}"/>
              </a:ext>
            </a:extLst>
          </p:cNvPr>
          <p:cNvSpPr txBox="1"/>
          <p:nvPr/>
        </p:nvSpPr>
        <p:spPr>
          <a:xfrm>
            <a:off x="1876408" y="107868"/>
            <a:ext cx="82105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en-IE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8A291E88-D5FC-64F3-22EA-5ABA271A1F1C}"/>
              </a:ext>
            </a:extLst>
          </p:cNvPr>
          <p:cNvSpPr txBox="1"/>
          <p:nvPr/>
        </p:nvSpPr>
        <p:spPr>
          <a:xfrm>
            <a:off x="6567470" y="107868"/>
            <a:ext cx="96051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Neratinib</a:t>
            </a:r>
            <a:endParaRPr lang="en-IE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4410B058-01A6-1BA1-33AC-A7CDB760B3B6}"/>
              </a:ext>
            </a:extLst>
          </p:cNvPr>
          <p:cNvSpPr txBox="1"/>
          <p:nvPr/>
        </p:nvSpPr>
        <p:spPr>
          <a:xfrm>
            <a:off x="1805716" y="3484480"/>
            <a:ext cx="98937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Dasatinib</a:t>
            </a:r>
            <a:endParaRPr lang="en-IE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92DAD731-D96F-C971-63A3-5E405E5C3CCF}"/>
              </a:ext>
            </a:extLst>
          </p:cNvPr>
          <p:cNvSpPr txBox="1"/>
          <p:nvPr/>
        </p:nvSpPr>
        <p:spPr>
          <a:xfrm>
            <a:off x="6132438" y="3484480"/>
            <a:ext cx="196880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Neratinib + Dasatinib</a:t>
            </a:r>
            <a:endParaRPr lang="en-IE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350802C9-5B64-DAD5-E2A6-7B6C6E24D0FD}"/>
              </a:ext>
            </a:extLst>
          </p:cNvPr>
          <p:cNvSpPr txBox="1"/>
          <p:nvPr/>
        </p:nvSpPr>
        <p:spPr>
          <a:xfrm>
            <a:off x="9377569" y="868846"/>
            <a:ext cx="2609021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4: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Representative images of Caspase 3/7 activation in HCC1954-N cells (untreated control, neratinib, dasatinib, neratinib plus dasatinib. Images were acquired using the Incucyte S3 imaging system.</a:t>
            </a:r>
            <a:endParaRPr lang="en-IE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3740007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grey surface with small spots&#10;&#10;Description automatically generated">
            <a:extLst>
              <a:ext uri="{FF2B5EF4-FFF2-40B4-BE49-F238E27FC236}">
                <a16:creationId xmlns:a16="http://schemas.microsoft.com/office/drawing/2014/main" id="{EDA75DF6-0576-5979-6648-4FD5F7AFBEE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6388" y="1077808"/>
            <a:ext cx="2930585" cy="3940865"/>
          </a:xfrm>
          <a:prstGeom prst="rect">
            <a:avLst/>
          </a:prstGeom>
        </p:spPr>
      </p:pic>
      <p:pic>
        <p:nvPicPr>
          <p:cNvPr id="5" name="Picture 4" descr="A grey surface with small spots&#10;&#10;Description automatically generated with medium confidence">
            <a:extLst>
              <a:ext uri="{FF2B5EF4-FFF2-40B4-BE49-F238E27FC236}">
                <a16:creationId xmlns:a16="http://schemas.microsoft.com/office/drawing/2014/main" id="{4BC73FEE-7D83-D2DF-B539-74BD9A36D89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93219" y="1077808"/>
            <a:ext cx="2930585" cy="3940865"/>
          </a:xfrm>
          <a:prstGeom prst="rect">
            <a:avLst/>
          </a:prstGeom>
        </p:spPr>
      </p:pic>
      <p:pic>
        <p:nvPicPr>
          <p:cNvPr id="7" name="Picture 6" descr="A grey surface with a white strip&#10;&#10;Description automatically generated with medium confidence">
            <a:extLst>
              <a:ext uri="{FF2B5EF4-FFF2-40B4-BE49-F238E27FC236}">
                <a16:creationId xmlns:a16="http://schemas.microsoft.com/office/drawing/2014/main" id="{0AC203CA-60BA-2B9F-1BB5-06C8962B327C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60050" y="1077808"/>
            <a:ext cx="2930585" cy="3940866"/>
          </a:xfrm>
          <a:prstGeom prst="rect">
            <a:avLst/>
          </a:prstGeom>
        </p:spPr>
      </p:pic>
      <p:pic>
        <p:nvPicPr>
          <p:cNvPr id="9" name="Picture 8" descr="A grey background with small spots&#10;&#10;Description automatically generated">
            <a:extLst>
              <a:ext uri="{FF2B5EF4-FFF2-40B4-BE49-F238E27FC236}">
                <a16:creationId xmlns:a16="http://schemas.microsoft.com/office/drawing/2014/main" id="{3C103322-6F54-C617-BF5C-EDCFA0913695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26881" y="1077808"/>
            <a:ext cx="2930584" cy="3940865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E9F3D7B4-D7A5-7968-43E7-474426638614}"/>
              </a:ext>
            </a:extLst>
          </p:cNvPr>
          <p:cNvSpPr txBox="1"/>
          <p:nvPr/>
        </p:nvSpPr>
        <p:spPr>
          <a:xfrm>
            <a:off x="949187" y="5256972"/>
            <a:ext cx="988446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5: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Representative images of scratch wound healing in HCC1954-N cells (untreated control, neratinib, dasatinib, neratinib plus dasatinib. Images were acquired using the Incucyte S3 imaging system.</a:t>
            </a:r>
            <a:endParaRPr lang="en-IE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9620854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Chart, bar chart&#10;&#10;Description automatically generated">
            <a:extLst>
              <a:ext uri="{FF2B5EF4-FFF2-40B4-BE49-F238E27FC236}">
                <a16:creationId xmlns:a16="http://schemas.microsoft.com/office/drawing/2014/main" id="{64E57F3E-0103-7545-938A-8BB5EB54ED17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b="14433"/>
          <a:stretch/>
        </p:blipFill>
        <p:spPr>
          <a:xfrm>
            <a:off x="369887" y="702310"/>
            <a:ext cx="10998527" cy="4839356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F3AD3040-B896-A3A4-8858-F0A8CDF95C0D}"/>
              </a:ext>
            </a:extLst>
          </p:cNvPr>
          <p:cNvSpPr txBox="1"/>
          <p:nvPr/>
        </p:nvSpPr>
        <p:spPr>
          <a:xfrm>
            <a:off x="1310931" y="5632470"/>
            <a:ext cx="988446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6: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cratch wound analysis of HCC1954 and HCC1954-N cells. Cell migration was examined by scratch wound assay on the Incucyte S3 system. Error bars represent SEM of independent triplicate experiments.</a:t>
            </a:r>
            <a:endParaRPr lang="en-IE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9350743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>
            <a:extLst>
              <a:ext uri="{FF2B5EF4-FFF2-40B4-BE49-F238E27FC236}">
                <a16:creationId xmlns:a16="http://schemas.microsoft.com/office/drawing/2014/main" id="{A6CC31BE-9D62-BE5A-7BC1-39227C8A712D}"/>
              </a:ext>
            </a:extLst>
          </p:cNvPr>
          <p:cNvSpPr/>
          <p:nvPr/>
        </p:nvSpPr>
        <p:spPr>
          <a:xfrm>
            <a:off x="3084844" y="5220119"/>
            <a:ext cx="5782826" cy="749492"/>
          </a:xfrm>
          <a:prstGeom prst="rect">
            <a:avLst/>
          </a:prstGeom>
          <a:ln>
            <a:solidFill>
              <a:schemeClr val="bg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7: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Densitometry analysis of Western blotting of </a:t>
            </a:r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in vivo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HCC1954 tumours. Statistical significance determined by one-way ANOVA.</a:t>
            </a:r>
            <a:endParaRPr lang="en-IE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6CB0BF58-A979-B540-D4C5-87AF20F3F741}"/>
              </a:ext>
            </a:extLst>
          </p:cNvPr>
          <p:cNvGraphicFramePr>
            <a:graphicFrameLocks noChangeAspect="1"/>
          </p:cNvGraphicFramePr>
          <p:nvPr/>
        </p:nvGraphicFramePr>
        <p:xfrm>
          <a:off x="2916203" y="332677"/>
          <a:ext cx="5988741" cy="474676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8871433" imgH="7027891" progId="Prism9.Document">
                  <p:embed/>
                </p:oleObj>
              </mc:Choice>
              <mc:Fallback>
                <p:oleObj name="Prism 9" r:id="rId2" imgW="8871433" imgH="7027891" progId="Prism9.Document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id="{6CB0BF58-A979-B540-D4C5-87AF20F3F74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916203" y="332677"/>
                        <a:ext cx="5988741" cy="474676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405128093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Diagram&#10;&#10;Description automatically generated">
            <a:extLst>
              <a:ext uri="{FF2B5EF4-FFF2-40B4-BE49-F238E27FC236}">
                <a16:creationId xmlns:a16="http://schemas.microsoft.com/office/drawing/2014/main" id="{37841E96-33AE-57BD-3BC0-9BB14DA93CC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50962" y="339725"/>
            <a:ext cx="9423962" cy="6227763"/>
          </a:xfrm>
          <a:prstGeom prst="rect">
            <a:avLst/>
          </a:prstGeom>
        </p:spPr>
      </p:pic>
      <p:sp>
        <p:nvSpPr>
          <p:cNvPr id="3" name="Rectangle 2">
            <a:extLst>
              <a:ext uri="{FF2B5EF4-FFF2-40B4-BE49-F238E27FC236}">
                <a16:creationId xmlns:a16="http://schemas.microsoft.com/office/drawing/2014/main" id="{2E1CC039-6B85-80DF-03B7-AC5F75F52CA5}"/>
              </a:ext>
            </a:extLst>
          </p:cNvPr>
          <p:cNvSpPr/>
          <p:nvPr/>
        </p:nvSpPr>
        <p:spPr>
          <a:xfrm>
            <a:off x="5109587" y="5245240"/>
            <a:ext cx="5782826" cy="749492"/>
          </a:xfrm>
          <a:prstGeom prst="rect">
            <a:avLst/>
          </a:prstGeom>
          <a:ln>
            <a:solidFill>
              <a:schemeClr val="bg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8: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Kinome of dasatinib, bosutinib, and imatinib and table of Kd</a:t>
            </a:r>
            <a:r>
              <a:rPr lang="en-US" sz="1400" baseline="-25000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values for Src family members (Eid, et al., 2017)</a:t>
            </a:r>
            <a:endParaRPr lang="en-IE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6223113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Diagram&#10;&#10;Description automatically generated">
            <a:extLst>
              <a:ext uri="{FF2B5EF4-FFF2-40B4-BE49-F238E27FC236}">
                <a16:creationId xmlns:a16="http://schemas.microsoft.com/office/drawing/2014/main" id="{8D7719CD-13F4-AA7D-ED13-86EB1105142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33588" y="223121"/>
            <a:ext cx="8123916" cy="6411042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09D24F0E-EF49-48B3-B3AA-9F9323FF99AB}"/>
              </a:ext>
            </a:extLst>
          </p:cNvPr>
          <p:cNvSpPr/>
          <p:nvPr/>
        </p:nvSpPr>
        <p:spPr>
          <a:xfrm>
            <a:off x="2697982" y="5833069"/>
            <a:ext cx="6797709" cy="749492"/>
          </a:xfrm>
          <a:prstGeom prst="rect">
            <a:avLst/>
          </a:prstGeom>
          <a:ln>
            <a:solidFill>
              <a:schemeClr val="bg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9: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Diagram of pathway effects of neratinib plus dasatinib on HER family signalling. Created using BioRender.</a:t>
            </a:r>
            <a:endParaRPr lang="en-IE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047018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84</Words>
  <Application>Microsoft Office PowerPoint</Application>
  <PresentationFormat>Widescreen</PresentationFormat>
  <Paragraphs>10</Paragraphs>
  <Slides>9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4" baseType="lpstr">
      <vt:lpstr>Aptos</vt:lpstr>
      <vt:lpstr>Aptos Display</vt:lpstr>
      <vt:lpstr>Arial</vt:lpstr>
      <vt:lpstr>Office Theme</vt:lpstr>
      <vt:lpstr>Prism 9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Neil Conlon</dc:creator>
  <cp:lastModifiedBy>Neil Conlon</cp:lastModifiedBy>
  <cp:revision>1</cp:revision>
  <dcterms:created xsi:type="dcterms:W3CDTF">2024-08-06T12:44:54Z</dcterms:created>
  <dcterms:modified xsi:type="dcterms:W3CDTF">2024-08-06T12:45:19Z</dcterms:modified>
</cp:coreProperties>
</file>